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omments/modernComment_100_61DB3B5A.xml" ContentType="application/vnd.ms-powerpoint.comments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56" r:id="rId2"/>
    <p:sldId id="288" r:id="rId3"/>
    <p:sldId id="286" r:id="rId4"/>
    <p:sldId id="289" r:id="rId5"/>
    <p:sldId id="290" r:id="rId6"/>
  </p:sldIdLst>
  <p:sldSz cx="12192000" cy="16200438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B96630D-233B-E207-BA49-7844A21F5BC2}" name="Florian Dr. Reiter" initials="FD" userId="d39cc17a53f74385" providerId="Windows Live"/>
  <p188:author id="{0B2B2C31-C021-CED0-2A79-CC25EF083A9B}" name="ru48nin" initials="" userId="S::ru48nin@unimuenchen.onmicrosoft.com::c810bd22-0812-477d-bcd7-625680e9ec1c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eiter, Florian" initials="RF" lastIdx="5" clrIdx="0">
    <p:extLst>
      <p:ext uri="{19B8F6BF-5375-455C-9EA6-DF929625EA0E}">
        <p15:presenceInfo xmlns:p15="http://schemas.microsoft.com/office/powerpoint/2012/main" userId="Reiter, Florian" providerId="None"/>
      </p:ext>
    </p:extLst>
  </p:cmAuthor>
  <p:cmAuthor id="2" name="Florian Dr. Reiter" initials="FDR" lastIdx="3" clrIdx="1">
    <p:extLst>
      <p:ext uri="{19B8F6BF-5375-455C-9EA6-DF929625EA0E}">
        <p15:presenceInfo xmlns:p15="http://schemas.microsoft.com/office/powerpoint/2012/main" userId="d39cc17a53f74385" providerId="Windows Live"/>
      </p:ext>
    </p:extLst>
  </p:cmAuthor>
  <p:cmAuthor id="3" name="ru48nin" initials="" lastIdx="6" clrIdx="2">
    <p:extLst>
      <p:ext uri="{19B8F6BF-5375-455C-9EA6-DF929625EA0E}">
        <p15:presenceInfo xmlns:p15="http://schemas.microsoft.com/office/powerpoint/2012/main" userId="S::ru48nin@unimuenchen.onmicrosoft.com::c810bd22-0812-477d-bcd7-625680e9ec1c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536A"/>
    <a:srgbClr val="44546A"/>
    <a:srgbClr val="E9ECF6"/>
    <a:srgbClr val="CFD6EA"/>
    <a:srgbClr val="034E61"/>
    <a:srgbClr val="0432FF"/>
    <a:srgbClr val="2F559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230"/>
    <p:restoredTop sz="94783"/>
  </p:normalViewPr>
  <p:slideViewPr>
    <p:cSldViewPr snapToGrid="0">
      <p:cViewPr varScale="1">
        <p:scale>
          <a:sx n="46" d="100"/>
          <a:sy n="46" d="100"/>
        </p:scale>
        <p:origin x="246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omments/modernComment_100_61DB3B5A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24EDE12D-2ACF-0640-8E64-3D5291B2C4E0}" authorId="{6B96630D-233B-E207-BA49-7844A21F5BC2}" created="2024-09-09T18:21:20.597">
    <ac:txMkLst xmlns:ac="http://schemas.microsoft.com/office/drawing/2013/main/command">
      <pc:docMk xmlns:pc="http://schemas.microsoft.com/office/powerpoint/2013/main/command"/>
      <pc:sldMk xmlns:pc="http://schemas.microsoft.com/office/powerpoint/2013/main/command" cId="1641757530" sldId="256"/>
      <ac:spMk id="4" creationId="{00000000-0000-0000-0000-000000000000}"/>
      <ac:txMk cp="22">
        <ac:context len="192" hash="2355484164"/>
      </ac:txMk>
    </ac:txMkLst>
    <p188:pos x="4722863" y="1914026"/>
    <p188:txBody>
      <a:bodyPr/>
      <a:lstStyle/>
      <a:p>
        <a:r>
          <a:rPr lang="de-DE"/>
          <a:t>Prüfen</a:t>
        </a:r>
      </a:p>
    </p188:txBody>
  </p188:cm>
</p188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CBE83B-A996-D84A-9063-28429550AA85}" type="datetimeFigureOut">
              <a:rPr lang="de-DE" smtClean="0"/>
              <a:t>28.03.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38363" y="1241425"/>
            <a:ext cx="25209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de-DE"/>
              <a:t>Mastertextformat bearbeiten
Zweite Ebene
Dritte Ebene
Vierte Ebene
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03E814-0C72-674A-A8C4-711D5A2AB8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242051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51323"/>
            <a:ext cx="10363200" cy="5640152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08981"/>
            <a:ext cx="9144000" cy="3911355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35EDD-A5A0-424C-9A3D-F5E89AE402AD}" type="datetimeFigureOut">
              <a:rPr lang="de-DE" smtClean="0"/>
              <a:t>28.03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5FEDA-08CC-42FF-BD49-F2274DC7FD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3731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35EDD-A5A0-424C-9A3D-F5E89AE402AD}" type="datetimeFigureOut">
              <a:rPr lang="de-DE" smtClean="0"/>
              <a:t>28.03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5FEDA-08CC-42FF-BD49-F2274DC7FD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1380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2524"/>
            <a:ext cx="2628900" cy="13729122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2524"/>
            <a:ext cx="7734300" cy="13729122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35EDD-A5A0-424C-9A3D-F5E89AE402AD}" type="datetimeFigureOut">
              <a:rPr lang="de-DE" smtClean="0"/>
              <a:t>28.03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5FEDA-08CC-42FF-BD49-F2274DC7FD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7066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35EDD-A5A0-424C-9A3D-F5E89AE402AD}" type="datetimeFigureOut">
              <a:rPr lang="de-DE" smtClean="0"/>
              <a:t>28.03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5FEDA-08CC-42FF-BD49-F2274DC7FD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0833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38864"/>
            <a:ext cx="10515600" cy="6738931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41548"/>
            <a:ext cx="10515600" cy="3543845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35EDD-A5A0-424C-9A3D-F5E89AE402AD}" type="datetimeFigureOut">
              <a:rPr lang="de-DE" smtClean="0"/>
              <a:t>28.03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5FEDA-08CC-42FF-BD49-F2274DC7FD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13499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12617"/>
            <a:ext cx="5181600" cy="1027902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12617"/>
            <a:ext cx="5181600" cy="1027902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35EDD-A5A0-424C-9A3D-F5E89AE402AD}" type="datetimeFigureOut">
              <a:rPr lang="de-DE" smtClean="0"/>
              <a:t>28.03.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5FEDA-08CC-42FF-BD49-F2274DC7FD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8500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2527"/>
            <a:ext cx="10515600" cy="3131336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71359"/>
            <a:ext cx="5157787" cy="194630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17660"/>
            <a:ext cx="5157787" cy="870398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71359"/>
            <a:ext cx="5183188" cy="194630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17660"/>
            <a:ext cx="5183188" cy="870398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35EDD-A5A0-424C-9A3D-F5E89AE402AD}" type="datetimeFigureOut">
              <a:rPr lang="de-DE" smtClean="0"/>
              <a:t>28.03.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5FEDA-08CC-42FF-BD49-F2274DC7FD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7252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35EDD-A5A0-424C-9A3D-F5E89AE402AD}" type="datetimeFigureOut">
              <a:rPr lang="de-DE" smtClean="0"/>
              <a:t>28.03.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5FEDA-08CC-42FF-BD49-F2274DC7FD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7993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35EDD-A5A0-424C-9A3D-F5E89AE402AD}" type="datetimeFigureOut">
              <a:rPr lang="de-DE" smtClean="0"/>
              <a:t>28.03.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5FEDA-08CC-42FF-BD49-F2274DC7FD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3433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0029"/>
            <a:ext cx="3932237" cy="3780102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32567"/>
            <a:ext cx="6172200" cy="1151281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60131"/>
            <a:ext cx="3932237" cy="900399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35EDD-A5A0-424C-9A3D-F5E89AE402AD}" type="datetimeFigureOut">
              <a:rPr lang="de-DE" smtClean="0"/>
              <a:t>28.03.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5FEDA-08CC-42FF-BD49-F2274DC7FD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2841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0029"/>
            <a:ext cx="3932237" cy="3780102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32567"/>
            <a:ext cx="6172200" cy="11512811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60131"/>
            <a:ext cx="3932237" cy="900399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35EDD-A5A0-424C-9A3D-F5E89AE402AD}" type="datetimeFigureOut">
              <a:rPr lang="de-DE" smtClean="0"/>
              <a:t>28.03.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5FEDA-08CC-42FF-BD49-F2274DC7FD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0705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2527"/>
            <a:ext cx="10515600" cy="31313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12617"/>
            <a:ext cx="10515600" cy="1027902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15410"/>
            <a:ext cx="2743200" cy="8625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B35EDD-A5A0-424C-9A3D-F5E89AE402AD}" type="datetimeFigureOut">
              <a:rPr lang="de-DE" smtClean="0"/>
              <a:t>28.03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15410"/>
            <a:ext cx="4114800" cy="8625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15410"/>
            <a:ext cx="2743200" cy="8625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25FEDA-08CC-42FF-BD49-F2274DC7FD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91734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microsoft.com/office/2018/10/relationships/comments" Target="../comments/modernComment_100_61DB3B5A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1624149" y="5616327"/>
            <a:ext cx="8773885" cy="37856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sz="20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Supplement to the paper</a:t>
            </a:r>
          </a:p>
          <a:p>
            <a:pPr algn="ctr">
              <a:lnSpc>
                <a:spcPct val="150000"/>
              </a:lnSpc>
            </a:pPr>
            <a:endParaRPr lang="en-US" sz="2000" b="1" i="1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2000" b="1" i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Therapeutic sequences of systemic therapy after </a:t>
            </a:r>
            <a:r>
              <a:rPr lang="en-US" sz="2000" b="1" i="1" dirty="0" err="1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atezolizumab</a:t>
            </a:r>
            <a:r>
              <a:rPr lang="en-US" sz="2000" b="1" i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plus bevacizumab for hepatocellular carcinoma: Real-World analysis of the </a:t>
            </a:r>
            <a:r>
              <a:rPr lang="en-US" sz="2000" b="1" i="1" dirty="0" err="1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IMMUreal</a:t>
            </a:r>
            <a:r>
              <a:rPr lang="en-US" sz="2000" b="1" i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cohort</a:t>
            </a:r>
            <a:endParaRPr lang="de-DE" sz="2000" b="1" i="1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endParaRPr lang="de-DE" sz="2000" b="1" i="1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endParaRPr lang="en-US" sz="2000" b="1" i="1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20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February 2025</a:t>
            </a:r>
            <a:endParaRPr lang="de-DE" sz="20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1757530"/>
      </p:ext>
    </p:extLst>
  </p:cSld>
  <p:clrMapOvr>
    <a:masterClrMapping/>
  </p:clrMapOvr>
  <p:extLst>
    <p:ext uri="{6950BFC3-D8DA-4A85-94F7-54DA5524770B}">
      <p188:commentRel xmlns:p188="http://schemas.microsoft.com/office/powerpoint/2018/8/main" r:id="rId2"/>
    </p:ext>
  </p:extLs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2648607" y="14630400"/>
            <a:ext cx="78746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1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rvival outcomes across each therapeutic stag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survival curves depict survival rates following initiation of 1st, 2nd, and 3rd line therapies, based on data from n=124 (1st line), n=34 (2nd line), and n=15 (3rd line). The 95% confidence intervals are shown as dotted lines.</a:t>
            </a: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3049990" y="1793399"/>
            <a:ext cx="5433651" cy="129571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12514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9096" y="4155599"/>
            <a:ext cx="7761224" cy="4653870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2362401" y="9144000"/>
            <a:ext cx="78746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2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rvival outcomes between sorafenib and lenvatinib in the 2nd lin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survival curves depict survival rates for the two common 2nd line therapies: sorafenib (n=14) and lenvatinib (n=11).</a:t>
            </a:r>
          </a:p>
        </p:txBody>
      </p:sp>
    </p:spTree>
    <p:extLst>
      <p:ext uri="{BB962C8B-B14F-4D97-AF65-F5344CB8AC3E}">
        <p14:creationId xmlns:p14="http://schemas.microsoft.com/office/powerpoint/2010/main" val="35327753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AE80364-4371-4197-D1EF-FA7DEE49DB7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3424931"/>
              </p:ext>
            </p:extLst>
          </p:nvPr>
        </p:nvGraphicFramePr>
        <p:xfrm>
          <a:off x="2362988" y="4273483"/>
          <a:ext cx="7348520" cy="239184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27852">
                  <a:extLst>
                    <a:ext uri="{9D8B030D-6E8A-4147-A177-3AD203B41FA5}">
                      <a16:colId xmlns:a16="http://schemas.microsoft.com/office/drawing/2014/main" val="3490763996"/>
                    </a:ext>
                  </a:extLst>
                </a:gridCol>
                <a:gridCol w="2420668">
                  <a:extLst>
                    <a:ext uri="{9D8B030D-6E8A-4147-A177-3AD203B41FA5}">
                      <a16:colId xmlns:a16="http://schemas.microsoft.com/office/drawing/2014/main" val="1113029897"/>
                    </a:ext>
                  </a:extLst>
                </a:gridCol>
              </a:tblGrid>
              <a:tr h="654488">
                <a:tc>
                  <a:txBody>
                    <a:bodyPr/>
                    <a:lstStyle/>
                    <a:p>
                      <a:pPr algn="l"/>
                      <a:r>
                        <a:rPr lang="en-CA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view of </a:t>
                      </a:r>
                      <a:r>
                        <a:rPr lang="en-CA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sons for disruption specified as other reasons in table 2.</a:t>
                      </a:r>
                      <a:endParaRPr lang="en-CA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1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47249123"/>
                  </a:ext>
                </a:extLst>
              </a:tr>
              <a:tr h="1402474">
                <a:tc>
                  <a:txBody>
                    <a:bodyPr/>
                    <a:lstStyle/>
                    <a:p>
                      <a:pPr marL="0" algn="l"/>
                      <a:r>
                        <a:rPr lang="en-CA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 reasons for disruption of 1</a:t>
                      </a:r>
                      <a:r>
                        <a:rPr lang="en-CA" sz="12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 </a:t>
                      </a:r>
                      <a:r>
                        <a:rPr lang="en-CA" sz="1200" b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 therapy, n (%)</a:t>
                      </a:r>
                      <a:endParaRPr lang="en-CA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144000" algn="l"/>
                      <a:r>
                        <a:rPr lang="en-CA" sz="1200" b="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Tx</a:t>
                      </a:r>
                      <a:endParaRPr lang="en-CA" sz="1200" b="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144000" algn="l"/>
                      <a:r>
                        <a:rPr lang="en-CA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ection</a:t>
                      </a:r>
                    </a:p>
                    <a:p>
                      <a:pPr marL="144000" algn="l"/>
                      <a:r>
                        <a:rPr lang="en-CA" sz="1200" b="0" kern="1200" baseline="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epsis</a:t>
                      </a:r>
                    </a:p>
                    <a:p>
                      <a:pPr marL="144000" algn="l"/>
                      <a:r>
                        <a:rPr lang="de-DE" sz="1200" b="0" kern="1200" baseline="0" dirty="0" err="1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hronic</a:t>
                      </a:r>
                      <a:r>
                        <a:rPr lang="de-DE" sz="1200" b="0" kern="1200" baseline="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kern="1200" baseline="0" dirty="0" err="1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flammatory</a:t>
                      </a:r>
                      <a:r>
                        <a:rPr lang="de-DE" sz="1200" b="0" kern="1200" baseline="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kern="1200" baseline="0" dirty="0" err="1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emyelinating</a:t>
                      </a:r>
                      <a:r>
                        <a:rPr lang="de-DE" sz="1200" b="0" kern="1200" baseline="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kern="1200" baseline="0" dirty="0" err="1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olyneuropathy</a:t>
                      </a:r>
                      <a:endParaRPr lang="de-DE" sz="1200" b="0" kern="1200" baseline="0" dirty="0">
                        <a:solidFill>
                          <a:schemeClr val="dk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144000" algn="l"/>
                      <a:r>
                        <a:rPr lang="de-DE" sz="1200" b="0" kern="1200" baseline="0" dirty="0" err="1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compliance</a:t>
                      </a:r>
                      <a:endParaRPr lang="de-DE" sz="1200" b="0" kern="1200" baseline="0" dirty="0">
                        <a:solidFill>
                          <a:schemeClr val="dk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144000" algn="l"/>
                      <a:r>
                        <a:rPr lang="de-DE" sz="1200" b="0" kern="1200" baseline="0" dirty="0" err="1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orsening</a:t>
                      </a:r>
                      <a:r>
                        <a:rPr lang="de-DE" sz="1200" b="0" kern="1200" baseline="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kern="1200" baseline="0" dirty="0" err="1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of</a:t>
                      </a:r>
                      <a:r>
                        <a:rPr lang="de-DE" sz="1200" b="0" kern="1200" baseline="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kern="1200" baseline="0" dirty="0" err="1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erformace</a:t>
                      </a:r>
                      <a:r>
                        <a:rPr lang="de-DE" sz="1200" b="0" kern="1200" baseline="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kern="1200" baseline="0" dirty="0" err="1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tatus</a:t>
                      </a:r>
                      <a:endParaRPr lang="de-DE" sz="1200" b="0" kern="1200" baseline="0" dirty="0">
                        <a:solidFill>
                          <a:schemeClr val="dk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144000" algn="l"/>
                      <a:r>
                        <a:rPr lang="de-DE" sz="1200" b="0" kern="1200" baseline="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atch and </a:t>
                      </a:r>
                      <a:r>
                        <a:rPr lang="de-DE" sz="1200" b="0" kern="1200" baseline="0" dirty="0" err="1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ait</a:t>
                      </a:r>
                      <a:r>
                        <a:rPr lang="de-DE" sz="1200" b="0" kern="1200" baseline="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kern="1200" baseline="0" dirty="0" err="1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rcedure</a:t>
                      </a:r>
                      <a:endParaRPr lang="de-DE" sz="1200" b="0" kern="1200" baseline="0" dirty="0">
                        <a:solidFill>
                          <a:schemeClr val="dk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144000" algn="l"/>
                      <a:r>
                        <a:rPr lang="de-DE" sz="1200" b="0" kern="1200" baseline="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ost </a:t>
                      </a:r>
                      <a:r>
                        <a:rPr lang="de-DE" sz="1200" b="0" kern="1200" baseline="0" dirty="0" err="1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o</a:t>
                      </a:r>
                      <a:r>
                        <a:rPr lang="de-DE" sz="1200" b="0" kern="1200" baseline="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follow </a:t>
                      </a:r>
                      <a:r>
                        <a:rPr lang="de-DE" sz="1200" b="0" kern="1200" baseline="0" dirty="0" err="1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p</a:t>
                      </a:r>
                      <a:endParaRPr lang="en-CA" sz="1200" b="0" kern="1200" baseline="0" dirty="0">
                        <a:solidFill>
                          <a:schemeClr val="dk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CA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CA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  <a:p>
                      <a:pPr algn="ctr"/>
                      <a:r>
                        <a:rPr lang="en-CA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  <a:p>
                      <a:pPr algn="ctr"/>
                      <a:r>
                        <a:rPr lang="en-CA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  <a:p>
                      <a:pPr algn="ctr"/>
                      <a:r>
                        <a:rPr lang="en-CA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  <a:p>
                      <a:pPr algn="ctr"/>
                      <a:r>
                        <a:rPr lang="en-CA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  <a:p>
                      <a:pPr algn="ctr"/>
                      <a:r>
                        <a:rPr lang="en-CA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  <a:p>
                      <a:pPr algn="ctr"/>
                      <a:r>
                        <a:rPr lang="en-CA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  <a:p>
                      <a:pPr algn="ctr"/>
                      <a:r>
                        <a:rPr lang="en-CA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2081249"/>
                  </a:ext>
                </a:extLst>
              </a:tr>
            </a:tbl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85ABC87C-3119-8234-41FB-9E8B37FDF45F}"/>
              </a:ext>
            </a:extLst>
          </p:cNvPr>
          <p:cNvSpPr txBox="1"/>
          <p:nvPr/>
        </p:nvSpPr>
        <p:spPr>
          <a:xfrm>
            <a:off x="2362988" y="6665331"/>
            <a:ext cx="73485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1.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verview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ther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easons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disruption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first-line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herap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pecifie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eason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lassifi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the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ause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rap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isrupt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unde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tezo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ev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ention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in Table 2.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43756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C94BE66-F3FE-A75A-5F63-63A3F51A212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1EF4CF3C-7AE5-E0A4-3E3D-9E811A9CFE2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8040276"/>
              </p:ext>
            </p:extLst>
          </p:nvPr>
        </p:nvGraphicFramePr>
        <p:xfrm>
          <a:off x="2686050" y="5981478"/>
          <a:ext cx="6819900" cy="4237356"/>
        </p:xfrm>
        <a:graphic>
          <a:graphicData uri="http://schemas.openxmlformats.org/drawingml/2006/table">
            <a:tbl>
              <a:tblPr firstRow="1" firstCol="1" bandRow="1"/>
              <a:tblGrid>
                <a:gridCol w="3142223">
                  <a:extLst>
                    <a:ext uri="{9D8B030D-6E8A-4147-A177-3AD203B41FA5}">
                      <a16:colId xmlns:a16="http://schemas.microsoft.com/office/drawing/2014/main" val="3038315096"/>
                    </a:ext>
                  </a:extLst>
                </a:gridCol>
                <a:gridCol w="1438677">
                  <a:extLst>
                    <a:ext uri="{9D8B030D-6E8A-4147-A177-3AD203B41FA5}">
                      <a16:colId xmlns:a16="http://schemas.microsoft.com/office/drawing/2014/main" val="3156150064"/>
                    </a:ext>
                  </a:extLst>
                </a:gridCol>
                <a:gridCol w="1350387">
                  <a:extLst>
                    <a:ext uri="{9D8B030D-6E8A-4147-A177-3AD203B41FA5}">
                      <a16:colId xmlns:a16="http://schemas.microsoft.com/office/drawing/2014/main" val="3901858741"/>
                    </a:ext>
                  </a:extLst>
                </a:gridCol>
                <a:gridCol w="888613">
                  <a:extLst>
                    <a:ext uri="{9D8B030D-6E8A-4147-A177-3AD203B41FA5}">
                      <a16:colId xmlns:a16="http://schemas.microsoft.com/office/drawing/2014/main" val="104111002"/>
                    </a:ext>
                  </a:extLst>
                </a:gridCol>
              </a:tblGrid>
              <a:tr h="231140"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DE" sz="12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Predictors for transition to </a:t>
                      </a:r>
                      <a:r>
                        <a:rPr lang="en-US" sz="12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2</a:t>
                      </a:r>
                      <a:r>
                        <a:rPr lang="en-US" sz="1200" b="1" baseline="300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nd</a:t>
                      </a:r>
                      <a:r>
                        <a:rPr lang="en-US" sz="12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 line therapy</a:t>
                      </a:r>
                      <a:endParaRPr lang="en-DE" sz="1200" b="1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4636590"/>
                  </a:ext>
                </a:extLst>
              </a:tr>
              <a:tr h="44577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DE" sz="12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Variable</a:t>
                      </a:r>
                      <a:endParaRPr lang="en-DE" sz="1200" b="1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Univariate</a:t>
                      </a:r>
                      <a:endParaRPr lang="en-DE" sz="12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Odd's ratio</a:t>
                      </a:r>
                      <a:endParaRPr lang="en-DE" sz="12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95% (CI)</a:t>
                      </a:r>
                      <a:endParaRPr lang="en-DE" sz="12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p-value</a:t>
                      </a:r>
                      <a:endParaRPr lang="en-DE" sz="12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1643250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DE" sz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Age</a:t>
                      </a:r>
                      <a:endParaRPr lang="en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1.014</a:t>
                      </a:r>
                      <a:endParaRPr lang="en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9680 to 1.064</a:t>
                      </a:r>
                      <a:endParaRPr lang="en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5564</a:t>
                      </a:r>
                      <a:endParaRPr lang="en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62756903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DE" sz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Sex (male)</a:t>
                      </a:r>
                      <a:endParaRPr lang="en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7222</a:t>
                      </a:r>
                      <a:endParaRPr lang="en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2568 to 2.047</a:t>
                      </a:r>
                      <a:endParaRPr lang="en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5346</a:t>
                      </a:r>
                      <a:endParaRPr lang="en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82532048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ECOG PS ≥ 1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6914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2465 to 1.836</a:t>
                      </a:r>
                      <a:endParaRPr lang="en-DE" sz="1200" b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4668</a:t>
                      </a:r>
                      <a:endParaRPr lang="en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9580328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Liver cirrhosis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4156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1425 to 1.165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0979</a:t>
                      </a:r>
                      <a:endParaRPr lang="en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5172433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CPS B (CPS A as reference)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1406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02085 to 0.5625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0143</a:t>
                      </a:r>
                      <a:endParaRPr lang="en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016058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DE" sz="1200" b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ALBI Grade ≥ 1 (Grade 0 as reference)</a:t>
                      </a:r>
                      <a:endParaRPr lang="en-DE" sz="1200" b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3044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1207 to 0.7384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0097</a:t>
                      </a:r>
                      <a:endParaRPr lang="en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4691005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DE" sz="1200" b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History of hepatic decompensation</a:t>
                      </a:r>
                      <a:endParaRPr lang="en-DE" sz="1200" b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6552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2070 to 1.901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4482</a:t>
                      </a:r>
                      <a:endParaRPr lang="en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2640117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BCLC stage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   BCLC A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   BCLC B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   BCLC C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reference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1.397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1.324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4332 to 4.807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3949 to 4.702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5815</a:t>
                      </a:r>
                      <a:endParaRPr lang="en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6531</a:t>
                      </a:r>
                      <a:endParaRPr lang="en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6218118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Extrahepatic spread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9667</a:t>
                      </a:r>
                      <a:endParaRPr lang="en-DE" sz="1200" b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3956 to 2.339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9401</a:t>
                      </a:r>
                      <a:endParaRPr lang="en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3256508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DE" sz="1200" b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acrovascular invasion</a:t>
                      </a:r>
                      <a:endParaRPr lang="en-DE" sz="1200" b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7977</a:t>
                      </a:r>
                      <a:endParaRPr lang="en-DE" sz="1200" b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2800 to 2.172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6622</a:t>
                      </a:r>
                      <a:endParaRPr lang="en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2576876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DE" sz="1200" b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Presence of GE varices</a:t>
                      </a:r>
                      <a:endParaRPr lang="en-DE" sz="1200" b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4816</a:t>
                      </a:r>
                      <a:endParaRPr lang="en-DE" sz="1200" b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1933 to 1.161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1082</a:t>
                      </a:r>
                      <a:endParaRPr lang="en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7563579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AFP &gt; 400 ng/ml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8462</a:t>
                      </a:r>
                      <a:endParaRPr lang="en-DE" sz="1200" b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2939 to 2.334</a:t>
                      </a:r>
                      <a:endParaRPr lang="en-DE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DE" sz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7496</a:t>
                      </a:r>
                      <a:endParaRPr lang="en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20326473"/>
                  </a:ext>
                </a:extLst>
              </a:tr>
            </a:tbl>
          </a:graphicData>
        </a:graphic>
      </p:graphicFrame>
      <p:sp>
        <p:nvSpPr>
          <p:cNvPr id="6" name="Textfeld 4">
            <a:extLst>
              <a:ext uri="{FF2B5EF4-FFF2-40B4-BE49-F238E27FC236}">
                <a16:creationId xmlns:a16="http://schemas.microsoft.com/office/drawing/2014/main" id="{EDB0E5F1-210B-7FDD-AE01-36E953732FCD}"/>
              </a:ext>
            </a:extLst>
          </p:cNvPr>
          <p:cNvSpPr txBox="1"/>
          <p:nvPr/>
        </p:nvSpPr>
        <p:spPr>
          <a:xfrm>
            <a:off x="2686050" y="10218960"/>
            <a:ext cx="672299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2.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Predictors for transition to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line therapy</a:t>
            </a:r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Odd’s ratio for transition to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nd line therapy 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was assessed by univariate logistic regression, with an Odd’s ratio &lt; 1 indicating a decreased odd of transition to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ine therapy. Patients with ongoing 1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ine therapy, or patients with local treatment modalities following 1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ine therapy (transplant, resection, locoregional therapies) were excluded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. Abbreviations: ALBI, Albumin-Bilirubin; BCLC, Barcelona Clinic Liver Cancer; CI, confidence interval; CPS, Child-Pugh score; ECOG, Eastern Cooperative Oncology Group Peformance Status; GE varices, gastoesophageal varices.</a:t>
            </a:r>
          </a:p>
          <a:p>
            <a:pPr algn="just"/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8398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485</Words>
  <Application>Microsoft Macintosh PowerPoint</Application>
  <PresentationFormat>Benutzerdefiniert</PresentationFormat>
  <Paragraphs>96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KW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eiter, Florian</dc:creator>
  <cp:lastModifiedBy>Florian Dr. Reiter</cp:lastModifiedBy>
  <cp:revision>307</cp:revision>
  <cp:lastPrinted>2023-07-20T16:11:22Z</cp:lastPrinted>
  <dcterms:created xsi:type="dcterms:W3CDTF">2023-06-25T12:06:50Z</dcterms:created>
  <dcterms:modified xsi:type="dcterms:W3CDTF">2025-03-28T12:42:41Z</dcterms:modified>
</cp:coreProperties>
</file>